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58" r:id="rId4"/>
    <p:sldId id="292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7E9639D4-E3E2-4D34-9284-5A2195B3D0D7}" styleName="Helle Formatvorlag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C083E6E3-FA7D-4D7B-A595-EF9225AFEA82}" styleName="Helle Formatvorlage 1 - Akz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53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3135C-0412-4CF8-A941-2226CF4D8E1F}" type="datetimeFigureOut">
              <a:rPr lang="en-GB" smtClean="0"/>
              <a:t>18/09/2025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C9AC20-906F-4091-BD31-D100C23F9A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57709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3135C-0412-4CF8-A941-2226CF4D8E1F}" type="datetimeFigureOut">
              <a:rPr lang="en-GB" smtClean="0"/>
              <a:t>18/09/2025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C9AC20-906F-4091-BD31-D100C23F9A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47918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3135C-0412-4CF8-A941-2226CF4D8E1F}" type="datetimeFigureOut">
              <a:rPr lang="en-GB" smtClean="0"/>
              <a:t>18/09/2025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C9AC20-906F-4091-BD31-D100C23F9A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7890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3135C-0412-4CF8-A941-2226CF4D8E1F}" type="datetimeFigureOut">
              <a:rPr lang="en-GB" smtClean="0"/>
              <a:t>18/09/2025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C9AC20-906F-4091-BD31-D100C23F9A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7718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3135C-0412-4CF8-A941-2226CF4D8E1F}" type="datetimeFigureOut">
              <a:rPr lang="en-GB" smtClean="0"/>
              <a:t>18/09/2025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C9AC20-906F-4091-BD31-D100C23F9A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48904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3135C-0412-4CF8-A941-2226CF4D8E1F}" type="datetimeFigureOut">
              <a:rPr lang="en-GB" smtClean="0"/>
              <a:t>18/09/2025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C9AC20-906F-4091-BD31-D100C23F9A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7434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3135C-0412-4CF8-A941-2226CF4D8E1F}" type="datetimeFigureOut">
              <a:rPr lang="en-GB" smtClean="0"/>
              <a:t>18/09/2025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C9AC20-906F-4091-BD31-D100C23F9A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89825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3135C-0412-4CF8-A941-2226CF4D8E1F}" type="datetimeFigureOut">
              <a:rPr lang="en-GB" smtClean="0"/>
              <a:t>18/09/2025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C9AC20-906F-4091-BD31-D100C23F9A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9540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3135C-0412-4CF8-A941-2226CF4D8E1F}" type="datetimeFigureOut">
              <a:rPr lang="en-GB" smtClean="0"/>
              <a:t>18/09/2025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C9AC20-906F-4091-BD31-D100C23F9A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8058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3135C-0412-4CF8-A941-2226CF4D8E1F}" type="datetimeFigureOut">
              <a:rPr lang="en-GB" smtClean="0"/>
              <a:t>18/09/2025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C9AC20-906F-4091-BD31-D100C23F9A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1525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3135C-0412-4CF8-A941-2226CF4D8E1F}" type="datetimeFigureOut">
              <a:rPr lang="en-GB" smtClean="0"/>
              <a:t>18/09/2025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C9AC20-906F-4091-BD31-D100C23F9A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27539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C3135C-0412-4CF8-A941-2226CF4D8E1F}" type="datetimeFigureOut">
              <a:rPr lang="en-GB" smtClean="0"/>
              <a:t>18/09/2025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C9AC20-906F-4091-BD31-D100C23F9A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20062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4"/>
          <p:cNvSpPr txBox="1"/>
          <p:nvPr/>
        </p:nvSpPr>
        <p:spPr>
          <a:xfrm>
            <a:off x="154794" y="3961744"/>
            <a:ext cx="108821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1.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contraction responses to PHE are presented as maximal contraction (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GB" sz="12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pEC50 values. The maximal relaxation responses to ACH or SNP are expressed as a percentage reduction of the maximal contractile response to 10 µM PHE. As aortic rings did not show any relaxation in the presence of L-NAME in all experiments, the data is excluded from the table. All values are shown as mean ± SEM.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GB" sz="12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pEC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etween the two groups are compared using Student's t-test, and the significant values are represented in the table. ACH, acetylcholine; INDO, indomethacin; SNP, sodium nitroprusside; NAC, N-acetyl cysteine.</a:t>
            </a:r>
          </a:p>
        </p:txBody>
      </p:sp>
      <p:sp>
        <p:nvSpPr>
          <p:cNvPr id="5" name="Rechteck 4"/>
          <p:cNvSpPr/>
          <p:nvPr/>
        </p:nvSpPr>
        <p:spPr>
          <a:xfrm>
            <a:off x="84455" y="540264"/>
            <a:ext cx="1116969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de-DE" sz="1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able 1. The </a:t>
            </a:r>
            <a:r>
              <a:rPr lang="de-DE" sz="1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fect</a:t>
            </a:r>
            <a:r>
              <a:rPr lang="de-DE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ute</a:t>
            </a:r>
            <a:r>
              <a:rPr lang="de-DE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emia on </a:t>
            </a:r>
            <a:r>
              <a:rPr lang="de-DE" sz="1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actile</a:t>
            </a:r>
            <a:r>
              <a:rPr lang="de-DE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DE" sz="1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dothelial-dependent</a:t>
            </a:r>
            <a:r>
              <a:rPr lang="de-DE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-independent </a:t>
            </a:r>
            <a:r>
              <a:rPr lang="de-DE" sz="1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laxation</a:t>
            </a:r>
            <a:r>
              <a:rPr lang="de-DE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sponses</a:t>
            </a:r>
            <a:r>
              <a:rPr lang="de-DE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4h post-AMI in </a:t>
            </a:r>
            <a:r>
              <a:rPr lang="de-DE" sz="1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orta</a:t>
            </a:r>
            <a:r>
              <a:rPr lang="de-DE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GB" sz="1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16080"/>
              </p:ext>
            </p:extLst>
          </p:nvPr>
        </p:nvGraphicFramePr>
        <p:xfrm>
          <a:off x="215510" y="1266741"/>
          <a:ext cx="10760716" cy="2288488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2340284">
                  <a:extLst>
                    <a:ext uri="{9D8B030D-6E8A-4147-A177-3AD203B41FA5}">
                      <a16:colId xmlns:a16="http://schemas.microsoft.com/office/drawing/2014/main" val="1446733262"/>
                    </a:ext>
                  </a:extLst>
                </a:gridCol>
                <a:gridCol w="1158670">
                  <a:extLst>
                    <a:ext uri="{9D8B030D-6E8A-4147-A177-3AD203B41FA5}">
                      <a16:colId xmlns:a16="http://schemas.microsoft.com/office/drawing/2014/main" val="2978270723"/>
                    </a:ext>
                  </a:extLst>
                </a:gridCol>
                <a:gridCol w="1158670">
                  <a:extLst>
                    <a:ext uri="{9D8B030D-6E8A-4147-A177-3AD203B41FA5}">
                      <a16:colId xmlns:a16="http://schemas.microsoft.com/office/drawing/2014/main" val="104651769"/>
                    </a:ext>
                  </a:extLst>
                </a:gridCol>
                <a:gridCol w="665374">
                  <a:extLst>
                    <a:ext uri="{9D8B030D-6E8A-4147-A177-3AD203B41FA5}">
                      <a16:colId xmlns:a16="http://schemas.microsoft.com/office/drawing/2014/main" val="65024287"/>
                    </a:ext>
                  </a:extLst>
                </a:gridCol>
                <a:gridCol w="1158670">
                  <a:extLst>
                    <a:ext uri="{9D8B030D-6E8A-4147-A177-3AD203B41FA5}">
                      <a16:colId xmlns:a16="http://schemas.microsoft.com/office/drawing/2014/main" val="3014617308"/>
                    </a:ext>
                  </a:extLst>
                </a:gridCol>
                <a:gridCol w="1158670">
                  <a:extLst>
                    <a:ext uri="{9D8B030D-6E8A-4147-A177-3AD203B41FA5}">
                      <a16:colId xmlns:a16="http://schemas.microsoft.com/office/drawing/2014/main" val="978853232"/>
                    </a:ext>
                  </a:extLst>
                </a:gridCol>
                <a:gridCol w="665374">
                  <a:extLst>
                    <a:ext uri="{9D8B030D-6E8A-4147-A177-3AD203B41FA5}">
                      <a16:colId xmlns:a16="http://schemas.microsoft.com/office/drawing/2014/main" val="3730192628"/>
                    </a:ext>
                  </a:extLst>
                </a:gridCol>
                <a:gridCol w="1227502">
                  <a:extLst>
                    <a:ext uri="{9D8B030D-6E8A-4147-A177-3AD203B41FA5}">
                      <a16:colId xmlns:a16="http://schemas.microsoft.com/office/drawing/2014/main" val="2133208487"/>
                    </a:ext>
                  </a:extLst>
                </a:gridCol>
                <a:gridCol w="1227502">
                  <a:extLst>
                    <a:ext uri="{9D8B030D-6E8A-4147-A177-3AD203B41FA5}">
                      <a16:colId xmlns:a16="http://schemas.microsoft.com/office/drawing/2014/main" val="1856780146"/>
                    </a:ext>
                  </a:extLst>
                </a:gridCol>
              </a:tblGrid>
              <a:tr h="19615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pEC</a:t>
                      </a:r>
                      <a:r>
                        <a:rPr lang="en-GB" sz="1000" b="1" u="none" strike="noStrike" baseline="-25000" dirty="0">
                          <a:solidFill>
                            <a:srgbClr val="000000"/>
                          </a:solidFill>
                          <a:effectLst/>
                        </a:rPr>
                        <a:t>50</a:t>
                      </a:r>
                      <a:endParaRPr lang="en-GB" sz="1000" b="1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>
                          <a:solidFill>
                            <a:srgbClr val="000000"/>
                          </a:solidFill>
                          <a:effectLst/>
                        </a:rPr>
                        <a:t>E</a:t>
                      </a:r>
                      <a:r>
                        <a:rPr lang="en-GB" sz="1000" b="1" u="none" strike="noStrike" baseline="-25000">
                          <a:solidFill>
                            <a:srgbClr val="000000"/>
                          </a:solidFill>
                          <a:effectLst/>
                        </a:rPr>
                        <a:t>max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>
                          <a:solidFill>
                            <a:srgbClr val="000000"/>
                          </a:solidFill>
                          <a:effectLst/>
                        </a:rPr>
                        <a:t>n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pEC</a:t>
                      </a:r>
                      <a:r>
                        <a:rPr lang="en-GB" sz="1000" b="1" u="none" strike="noStrike" baseline="-25000" dirty="0">
                          <a:solidFill>
                            <a:srgbClr val="000000"/>
                          </a:solidFill>
                          <a:effectLst/>
                        </a:rPr>
                        <a:t>50</a:t>
                      </a:r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>
                          <a:solidFill>
                            <a:srgbClr val="000000"/>
                          </a:solidFill>
                          <a:effectLst/>
                        </a:rPr>
                        <a:t>E</a:t>
                      </a:r>
                      <a:r>
                        <a:rPr lang="en-GB" sz="1000" b="1" u="none" strike="noStrike" baseline="-25000">
                          <a:solidFill>
                            <a:srgbClr val="000000"/>
                          </a:solidFill>
                          <a:effectLst/>
                        </a:rPr>
                        <a:t>max 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>
                          <a:solidFill>
                            <a:srgbClr val="000000"/>
                          </a:solidFill>
                          <a:effectLst/>
                        </a:rPr>
                        <a:t>n 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p-value pEC</a:t>
                      </a:r>
                      <a:r>
                        <a:rPr lang="en-GB" sz="1000" b="1" u="none" strike="noStrike" baseline="-25000" dirty="0">
                          <a:solidFill>
                            <a:srgbClr val="000000"/>
                          </a:solidFill>
                          <a:effectLst/>
                        </a:rPr>
                        <a:t>50</a:t>
                      </a:r>
                      <a:endParaRPr lang="en-GB" sz="1000" b="1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>
                          <a:solidFill>
                            <a:srgbClr val="000000"/>
                          </a:solidFill>
                          <a:effectLst/>
                        </a:rPr>
                        <a:t>p-value E</a:t>
                      </a:r>
                      <a:r>
                        <a:rPr lang="en-GB" sz="1000" b="1" u="none" strike="noStrike" baseline="-25000">
                          <a:solidFill>
                            <a:srgbClr val="000000"/>
                          </a:solidFill>
                          <a:effectLst/>
                        </a:rPr>
                        <a:t>max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3036190764"/>
                  </a:ext>
                </a:extLst>
              </a:tr>
              <a:tr h="17436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PHE (Indomethacin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2912449052"/>
                  </a:ext>
                </a:extLst>
              </a:tr>
              <a:tr h="174361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ham 24h AMI vs. Acute 24h AMI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77 ± 0.1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4.71 ± 0.5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92 ± 0.1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.58 ± 0.8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5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4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658069968"/>
                  </a:ext>
                </a:extLst>
              </a:tr>
              <a:tr h="174361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ham 24h + NAC vs. Acute 24h+NA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87 ± 0.1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.23 ± 0.7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90 ± 0.1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.74 ± 0.4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8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5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1659172700"/>
                  </a:ext>
                </a:extLst>
              </a:tr>
              <a:tr h="17436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PHE (Indomethacin +L-NAME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4023352802"/>
                  </a:ext>
                </a:extLst>
              </a:tr>
              <a:tr h="174361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ham 24h vs. Acute 24h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92 ± 0.0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.49 ± 0.5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.23 ± 0.2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.15 ± 1.5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2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8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484826024"/>
                  </a:ext>
                </a:extLst>
              </a:tr>
              <a:tr h="174361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ham 24h + NAC vs. Acute 24h+NA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.48 ± 0.1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1.80 ± 0.8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.46 ± 0.0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0.04 ± 0.6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8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1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3804510457"/>
                  </a:ext>
                </a:extLst>
              </a:tr>
              <a:tr h="17436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ACH (Indomethacin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3671073915"/>
                  </a:ext>
                </a:extLst>
              </a:tr>
              <a:tr h="174361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Sham 24h vs. Acute 24h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52 ± 0.1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2.45 ± 6.0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51 ± 0.2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5.22 ± 2.8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9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009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373574465"/>
                  </a:ext>
                </a:extLst>
              </a:tr>
              <a:tr h="174361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ham 24h + NAC vs. Acute 24h+NA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.25 ± 0.0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0.19 ± 4.5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.19 ± 0.1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4.05 ± 7.6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7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4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1415063259"/>
                  </a:ext>
                </a:extLst>
              </a:tr>
              <a:tr h="17436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SNP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789293903"/>
                  </a:ext>
                </a:extLst>
              </a:tr>
              <a:tr h="174361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ham 24h vs. Acute 24h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65 ± 0.0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95.44 ± 4.5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75 ± 0.0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5.75 ± 4.1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1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3700811991"/>
                  </a:ext>
                </a:extLst>
              </a:tr>
              <a:tr h="174361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ham 24h + NAC vs. Acute 24h+NA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.38 ± 0.0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99.47 ± 0.7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.38 ± 0.0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04.75 ± 2.6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318645895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406609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382539" y="969150"/>
            <a:ext cx="10515601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2. The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fect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ute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emia on </a:t>
            </a:r>
            <a:r>
              <a:rPr lang="de-DE" sz="1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actile</a:t>
            </a:r>
            <a:r>
              <a:rPr lang="de-DE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dothelial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pendednt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-independent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laxation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ponses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h post-AMI 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moral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tery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feld 4"/>
          <p:cNvSpPr txBox="1"/>
          <p:nvPr/>
        </p:nvSpPr>
        <p:spPr>
          <a:xfrm>
            <a:off x="439495" y="4675803"/>
            <a:ext cx="1040168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2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ontraction responses to PHE are presented as maximal contraction (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GB" sz="12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pEC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. The maximal relaxation responses to ACH or SNP are expressed as a percentage reduction of the maximal contractile response to 10 µM PHE. All values are shown as mean ± SEM.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GB" sz="12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pEC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etween the two groups are compared using Student's t-test, and the significant values are represented in the table. </a:t>
            </a:r>
            <a:r>
              <a:rPr lang="en-GB" sz="1200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H, acetyl choline; INDO, indomethacin; SNP, sodium nitroprusside; NAC, N-acetyl cysteine. All values are shown as mean ± SEM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620568"/>
              </p:ext>
            </p:extLst>
          </p:nvPr>
        </p:nvGraphicFramePr>
        <p:xfrm>
          <a:off x="496455" y="1959109"/>
          <a:ext cx="10287770" cy="2540199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2238438">
                  <a:extLst>
                    <a:ext uri="{9D8B030D-6E8A-4147-A177-3AD203B41FA5}">
                      <a16:colId xmlns:a16="http://schemas.microsoft.com/office/drawing/2014/main" val="18796352"/>
                    </a:ext>
                  </a:extLst>
                </a:gridCol>
                <a:gridCol w="1107914">
                  <a:extLst>
                    <a:ext uri="{9D8B030D-6E8A-4147-A177-3AD203B41FA5}">
                      <a16:colId xmlns:a16="http://schemas.microsoft.com/office/drawing/2014/main" val="2054082538"/>
                    </a:ext>
                  </a:extLst>
                </a:gridCol>
                <a:gridCol w="1107914">
                  <a:extLst>
                    <a:ext uri="{9D8B030D-6E8A-4147-A177-3AD203B41FA5}">
                      <a16:colId xmlns:a16="http://schemas.microsoft.com/office/drawing/2014/main" val="763222525"/>
                    </a:ext>
                  </a:extLst>
                </a:gridCol>
                <a:gridCol w="633093">
                  <a:extLst>
                    <a:ext uri="{9D8B030D-6E8A-4147-A177-3AD203B41FA5}">
                      <a16:colId xmlns:a16="http://schemas.microsoft.com/office/drawing/2014/main" val="2475595283"/>
                    </a:ext>
                  </a:extLst>
                </a:gridCol>
                <a:gridCol w="1107914">
                  <a:extLst>
                    <a:ext uri="{9D8B030D-6E8A-4147-A177-3AD203B41FA5}">
                      <a16:colId xmlns:a16="http://schemas.microsoft.com/office/drawing/2014/main" val="2002592167"/>
                    </a:ext>
                  </a:extLst>
                </a:gridCol>
                <a:gridCol w="1107914">
                  <a:extLst>
                    <a:ext uri="{9D8B030D-6E8A-4147-A177-3AD203B41FA5}">
                      <a16:colId xmlns:a16="http://schemas.microsoft.com/office/drawing/2014/main" val="255899682"/>
                    </a:ext>
                  </a:extLst>
                </a:gridCol>
                <a:gridCol w="633093">
                  <a:extLst>
                    <a:ext uri="{9D8B030D-6E8A-4147-A177-3AD203B41FA5}">
                      <a16:colId xmlns:a16="http://schemas.microsoft.com/office/drawing/2014/main" val="382976661"/>
                    </a:ext>
                  </a:extLst>
                </a:gridCol>
                <a:gridCol w="1175745">
                  <a:extLst>
                    <a:ext uri="{9D8B030D-6E8A-4147-A177-3AD203B41FA5}">
                      <a16:colId xmlns:a16="http://schemas.microsoft.com/office/drawing/2014/main" val="106390192"/>
                    </a:ext>
                  </a:extLst>
                </a:gridCol>
                <a:gridCol w="1175745">
                  <a:extLst>
                    <a:ext uri="{9D8B030D-6E8A-4147-A177-3AD203B41FA5}">
                      <a16:colId xmlns:a16="http://schemas.microsoft.com/office/drawing/2014/main" val="811658547"/>
                    </a:ext>
                  </a:extLst>
                </a:gridCol>
              </a:tblGrid>
              <a:tr h="16448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u="none" strike="noStrike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u="none" strike="noStrike">
                          <a:solidFill>
                            <a:srgbClr val="000000"/>
                          </a:solidFill>
                          <a:effectLst/>
                        </a:rPr>
                        <a:t>pEC50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u="none" strike="noStrike">
                          <a:solidFill>
                            <a:srgbClr val="000000"/>
                          </a:solidFill>
                          <a:effectLst/>
                        </a:rPr>
                        <a:t>E</a:t>
                      </a:r>
                      <a:r>
                        <a:rPr lang="en-GB" sz="900" b="1" u="none" strike="noStrike" baseline="-25000">
                          <a:solidFill>
                            <a:srgbClr val="000000"/>
                          </a:solidFill>
                          <a:effectLst/>
                        </a:rPr>
                        <a:t>max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u="none" strike="noStrike">
                          <a:solidFill>
                            <a:srgbClr val="000000"/>
                          </a:solidFill>
                          <a:effectLst/>
                        </a:rPr>
                        <a:t>n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pEC50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u="none" strike="noStrike">
                          <a:solidFill>
                            <a:srgbClr val="000000"/>
                          </a:solidFill>
                          <a:effectLst/>
                        </a:rPr>
                        <a:t>E</a:t>
                      </a:r>
                      <a:r>
                        <a:rPr lang="en-GB" sz="900" b="1" u="none" strike="noStrike" baseline="-25000">
                          <a:solidFill>
                            <a:srgbClr val="000000"/>
                          </a:solidFill>
                          <a:effectLst/>
                        </a:rPr>
                        <a:t>max</a:t>
                      </a:r>
                      <a:r>
                        <a:rPr lang="en-GB" sz="900" b="1" u="none" strike="noStrike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u="none" strike="noStrike">
                          <a:solidFill>
                            <a:srgbClr val="000000"/>
                          </a:solidFill>
                          <a:effectLst/>
                        </a:rPr>
                        <a:t>n 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u="none" strike="noStrike">
                          <a:solidFill>
                            <a:srgbClr val="000000"/>
                          </a:solidFill>
                          <a:effectLst/>
                        </a:rPr>
                        <a:t>p-value pEC50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u="none" strike="noStrike">
                          <a:solidFill>
                            <a:srgbClr val="000000"/>
                          </a:solidFill>
                          <a:effectLst/>
                        </a:rPr>
                        <a:t>p-value Emax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extLst>
                  <a:ext uri="{0D108BD9-81ED-4DB2-BD59-A6C34878D82A}">
                    <a16:rowId xmlns:a16="http://schemas.microsoft.com/office/drawing/2014/main" val="1758430198"/>
                  </a:ext>
                </a:extLst>
              </a:tr>
              <a:tr h="14953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PHE (Indomethacin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extLst>
                  <a:ext uri="{0D108BD9-81ED-4DB2-BD59-A6C34878D82A}">
                    <a16:rowId xmlns:a16="http://schemas.microsoft.com/office/drawing/2014/main" val="3173081598"/>
                  </a:ext>
                </a:extLst>
              </a:tr>
              <a:tr h="149531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ham 24h vs. Acute 24h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.27 ± 0.1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56 ± 1.3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4.85 ± 0.2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.12 ± 0.9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1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4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extLst>
                  <a:ext uri="{0D108BD9-81ED-4DB2-BD59-A6C34878D82A}">
                    <a16:rowId xmlns:a16="http://schemas.microsoft.com/office/drawing/2014/main" val="655806671"/>
                  </a:ext>
                </a:extLst>
              </a:tr>
              <a:tr h="149531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ham 24h + NAC vs. Acute 24h+NA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.02 ± 0.1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.91 ± 0.6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4.67 ± 0.18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.47 ± 0.6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extLst>
                  <a:ext uri="{0D108BD9-81ED-4DB2-BD59-A6C34878D82A}">
                    <a16:rowId xmlns:a16="http://schemas.microsoft.com/office/drawing/2014/main" val="3665461376"/>
                  </a:ext>
                </a:extLst>
              </a:tr>
              <a:tr h="14953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PHE (Indomethacin +L-NAME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extLst>
                  <a:ext uri="{0D108BD9-81ED-4DB2-BD59-A6C34878D82A}">
                    <a16:rowId xmlns:a16="http://schemas.microsoft.com/office/drawing/2014/main" val="3821220381"/>
                  </a:ext>
                </a:extLst>
              </a:tr>
              <a:tr h="149531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Sham 24h vs. Acute 24h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.99 ± 0.1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.20 ± 1.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.56 ± 0.1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.16 ± 0.85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5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4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extLst>
                  <a:ext uri="{0D108BD9-81ED-4DB2-BD59-A6C34878D82A}">
                    <a16:rowId xmlns:a16="http://schemas.microsoft.com/office/drawing/2014/main" val="221124724"/>
                  </a:ext>
                </a:extLst>
              </a:tr>
              <a:tr h="149531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ham 24h + NAC vs. Acute 24h+NA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.49 ± 0.1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9.26 ± 0.63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4.65 ± 0.2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36 ± 1.0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07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3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extLst>
                  <a:ext uri="{0D108BD9-81ED-4DB2-BD59-A6C34878D82A}">
                    <a16:rowId xmlns:a16="http://schemas.microsoft.com/office/drawing/2014/main" val="1908931619"/>
                  </a:ext>
                </a:extLst>
              </a:tr>
              <a:tr h="14953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ACH (Indomethacin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extLst>
                  <a:ext uri="{0D108BD9-81ED-4DB2-BD59-A6C34878D82A}">
                    <a16:rowId xmlns:a16="http://schemas.microsoft.com/office/drawing/2014/main" val="272331920"/>
                  </a:ext>
                </a:extLst>
              </a:tr>
              <a:tr h="149531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Sham 24h vs. Acute 24h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.55 ± 0.20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02.26 ± 2.3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86 ± 0.2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92.12 ± 8.37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4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2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extLst>
                  <a:ext uri="{0D108BD9-81ED-4DB2-BD59-A6C34878D82A}">
                    <a16:rowId xmlns:a16="http://schemas.microsoft.com/office/drawing/2014/main" val="2703676301"/>
                  </a:ext>
                </a:extLst>
              </a:tr>
              <a:tr h="149531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Sham 24h + NAC vs. Acute 24h+N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.30 ± 0.17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07.20 ± 1.1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51 ± 0.2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99.81 ± 2.7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0.03</a:t>
                      </a:r>
                      <a:endParaRPr lang="en-GB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3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extLst>
                  <a:ext uri="{0D108BD9-81ED-4DB2-BD59-A6C34878D82A}">
                    <a16:rowId xmlns:a16="http://schemas.microsoft.com/office/drawing/2014/main" val="3529879833"/>
                  </a:ext>
                </a:extLst>
              </a:tr>
              <a:tr h="14953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ACH (Indomethacin +L-NAME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extLst>
                  <a:ext uri="{0D108BD9-81ED-4DB2-BD59-A6C34878D82A}">
                    <a16:rowId xmlns:a16="http://schemas.microsoft.com/office/drawing/2014/main" val="124936462"/>
                  </a:ext>
                </a:extLst>
              </a:tr>
              <a:tr h="149531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ham 24h vs. Acute 24h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66 ± 0.2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4.73 ± 6.7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46 ± 0.1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2.29 ± 5.5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4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4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extLst>
                  <a:ext uri="{0D108BD9-81ED-4DB2-BD59-A6C34878D82A}">
                    <a16:rowId xmlns:a16="http://schemas.microsoft.com/office/drawing/2014/main" val="1192315863"/>
                  </a:ext>
                </a:extLst>
              </a:tr>
              <a:tr h="149531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ham 24h + NAC vs. Acute 24h+NA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.09 ± 0.1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3.40 ± 5.3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47 ± 0.1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93.68 ± 2.6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0.04</a:t>
                      </a:r>
                      <a:endParaRPr lang="en-GB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1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extLst>
                  <a:ext uri="{0D108BD9-81ED-4DB2-BD59-A6C34878D82A}">
                    <a16:rowId xmlns:a16="http://schemas.microsoft.com/office/drawing/2014/main" val="3684258926"/>
                  </a:ext>
                </a:extLst>
              </a:tr>
              <a:tr h="149531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SNP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extLst>
                  <a:ext uri="{0D108BD9-81ED-4DB2-BD59-A6C34878D82A}">
                    <a16:rowId xmlns:a16="http://schemas.microsoft.com/office/drawing/2014/main" val="2946373968"/>
                  </a:ext>
                </a:extLst>
              </a:tr>
              <a:tr h="149531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ham 24h vs. Acute 24h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.00 ± 0.1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16.52 ± 3.0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.10 ± 0.1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12.43 ± 4.9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6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4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extLst>
                  <a:ext uri="{0D108BD9-81ED-4DB2-BD59-A6C34878D82A}">
                    <a16:rowId xmlns:a16="http://schemas.microsoft.com/office/drawing/2014/main" val="406461326"/>
                  </a:ext>
                </a:extLst>
              </a:tr>
              <a:tr h="149531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Sham 24h + NAC vs. Acute 24h+N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.53 ± 0.1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08.14 ± 0.6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.23 ± 0.1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00.92 ± 1.2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0.07</a:t>
                      </a:r>
                      <a:endParaRPr lang="en-GB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0.0002</a:t>
                      </a:r>
                      <a:endParaRPr lang="en-GB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81" marR="5981" marT="5981" marB="0" anchor="b"/>
                </a:tc>
                <a:extLst>
                  <a:ext uri="{0D108BD9-81ED-4DB2-BD59-A6C34878D82A}">
                    <a16:rowId xmlns:a16="http://schemas.microsoft.com/office/drawing/2014/main" val="62774670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634414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444379" y="992373"/>
            <a:ext cx="10515601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3. The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fect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ute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emia on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dothelial-dependent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-independent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laxation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ponses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h post-AMI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phenous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tery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feld 4"/>
          <p:cNvSpPr txBox="1"/>
          <p:nvPr/>
        </p:nvSpPr>
        <p:spPr>
          <a:xfrm>
            <a:off x="395972" y="4998037"/>
            <a:ext cx="1061241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3.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contraction responses to PHE are presented as maximal contraction (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GB" sz="12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pEC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. The maximal relaxation responses to ACH or SNP are expressed as a percentage reduction of the maximal contractile response to 10 µM PHE. All values are shown as mean ± SEM.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GB" sz="12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pEC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etween the two groups are compared using Student's t-test, and the significant values are represented in the table. </a:t>
            </a:r>
            <a:r>
              <a:rPr lang="en-GB" sz="1200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H, acetyl choline; INDO, indomethacin; SNP, sodium nitroprusside; NAC, N-acetyl cysteine. All values are shown as mean ± SEM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0272064"/>
              </p:ext>
            </p:extLst>
          </p:nvPr>
        </p:nvGraphicFramePr>
        <p:xfrm>
          <a:off x="541196" y="1793574"/>
          <a:ext cx="10515601" cy="2603123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2286975">
                  <a:extLst>
                    <a:ext uri="{9D8B030D-6E8A-4147-A177-3AD203B41FA5}">
                      <a16:colId xmlns:a16="http://schemas.microsoft.com/office/drawing/2014/main" val="2223053672"/>
                    </a:ext>
                  </a:extLst>
                </a:gridCol>
                <a:gridCol w="1132277">
                  <a:extLst>
                    <a:ext uri="{9D8B030D-6E8A-4147-A177-3AD203B41FA5}">
                      <a16:colId xmlns:a16="http://schemas.microsoft.com/office/drawing/2014/main" val="3216396936"/>
                    </a:ext>
                  </a:extLst>
                </a:gridCol>
                <a:gridCol w="1132277">
                  <a:extLst>
                    <a:ext uri="{9D8B030D-6E8A-4147-A177-3AD203B41FA5}">
                      <a16:colId xmlns:a16="http://schemas.microsoft.com/office/drawing/2014/main" val="1073366010"/>
                    </a:ext>
                  </a:extLst>
                </a:gridCol>
                <a:gridCol w="650218">
                  <a:extLst>
                    <a:ext uri="{9D8B030D-6E8A-4147-A177-3AD203B41FA5}">
                      <a16:colId xmlns:a16="http://schemas.microsoft.com/office/drawing/2014/main" val="4259780456"/>
                    </a:ext>
                  </a:extLst>
                </a:gridCol>
                <a:gridCol w="1132277">
                  <a:extLst>
                    <a:ext uri="{9D8B030D-6E8A-4147-A177-3AD203B41FA5}">
                      <a16:colId xmlns:a16="http://schemas.microsoft.com/office/drawing/2014/main" val="4294143359"/>
                    </a:ext>
                  </a:extLst>
                </a:gridCol>
                <a:gridCol w="1132277">
                  <a:extLst>
                    <a:ext uri="{9D8B030D-6E8A-4147-A177-3AD203B41FA5}">
                      <a16:colId xmlns:a16="http://schemas.microsoft.com/office/drawing/2014/main" val="3031729390"/>
                    </a:ext>
                  </a:extLst>
                </a:gridCol>
                <a:gridCol w="650218">
                  <a:extLst>
                    <a:ext uri="{9D8B030D-6E8A-4147-A177-3AD203B41FA5}">
                      <a16:colId xmlns:a16="http://schemas.microsoft.com/office/drawing/2014/main" val="3993930903"/>
                    </a:ext>
                  </a:extLst>
                </a:gridCol>
                <a:gridCol w="1199541">
                  <a:extLst>
                    <a:ext uri="{9D8B030D-6E8A-4147-A177-3AD203B41FA5}">
                      <a16:colId xmlns:a16="http://schemas.microsoft.com/office/drawing/2014/main" val="2346380863"/>
                    </a:ext>
                  </a:extLst>
                </a:gridCol>
                <a:gridCol w="1199541">
                  <a:extLst>
                    <a:ext uri="{9D8B030D-6E8A-4147-A177-3AD203B41FA5}">
                      <a16:colId xmlns:a16="http://schemas.microsoft.com/office/drawing/2014/main" val="3738319271"/>
                    </a:ext>
                  </a:extLst>
                </a:gridCol>
              </a:tblGrid>
              <a:tr h="18161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C</a:t>
                      </a:r>
                      <a:r>
                        <a:rPr lang="en-GB" sz="1000" b="1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GB" sz="1000" b="1" i="0" u="none" strike="noStrike" baseline="-25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GB" sz="1000" b="1" u="none" strike="noStrike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C</a:t>
                      </a:r>
                      <a:r>
                        <a:rPr lang="en-GB" sz="1000" b="1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GB" sz="1000" b="1" u="none" strike="noStrike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</a:t>
                      </a:r>
                      <a:r>
                        <a:rPr lang="en-GB" sz="10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 pEC</a:t>
                      </a:r>
                      <a:r>
                        <a:rPr lang="en-GB" sz="1000" b="1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GB" sz="1000" b="1" i="0" u="none" strike="noStrike" baseline="-25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 E</a:t>
                      </a:r>
                      <a:r>
                        <a:rPr lang="en-GB" sz="1000" b="1" u="none" strike="noStrike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3004197634"/>
                  </a:ext>
                </a:extLst>
              </a:tr>
              <a:tr h="16143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 (Indomethacin)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1237953961"/>
                  </a:ext>
                </a:extLst>
              </a:tr>
              <a:tr h="161434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m 24h vs. Acute 24h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0 ± 1.6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47 ± 1.8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2 ± 0.2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88 ± 2.4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3317734945"/>
                  </a:ext>
                </a:extLst>
              </a:tr>
              <a:tr h="161434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m 24h + NAC vs. Acute 24h+NA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29 ± 0.11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46 ±1.43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79 ± 0.1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70 ± 1.7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3182729052"/>
                  </a:ext>
                </a:extLst>
              </a:tr>
              <a:tr h="16143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 (Indomethacin +L-NAME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2325726120"/>
                  </a:ext>
                </a:extLst>
              </a:tr>
              <a:tr h="161434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m 24h vs. Acute 24h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77 ± 0.1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2 ± 1.6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8 ± 0.2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03 ± 2.2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2639794354"/>
                  </a:ext>
                </a:extLst>
              </a:tr>
              <a:tr h="161434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m 24h + NAC vs. Acute 24h+NA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78 ± 0.1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96 ± 1.3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81 ± 0.1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93 ± 1.9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2155039720"/>
                  </a:ext>
                </a:extLst>
              </a:tr>
              <a:tr h="16143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H (Indomethacin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4269941169"/>
                  </a:ext>
                </a:extLst>
              </a:tr>
              <a:tr h="161434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m 24h vs. Acute 24h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9 ± 0.2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.44 ± 7.59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6.05 ± 0.3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.36 ± 12.41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3424858693"/>
                  </a:ext>
                </a:extLst>
              </a:tr>
              <a:tr h="161434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m 24h + NAC vs. Acute 24h+NA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84 ± 0.1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.00 ± 4.5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27 ± 0.2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.94 ± 7.57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628481111"/>
                  </a:ext>
                </a:extLst>
              </a:tr>
              <a:tr h="16143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H (Indomethacin +L-NAME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1912594678"/>
                  </a:ext>
                </a:extLst>
              </a:tr>
              <a:tr h="161434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m 24h vs. Acute 24h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0 ± 0.2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67 ± 6.7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8 ± 0.4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64 ± 7.9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800949922"/>
                  </a:ext>
                </a:extLst>
              </a:tr>
              <a:tr h="161434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m 24h + NAC vs. Acute 24h+NA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2 ± 0.1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59 ± 7.3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7 ± 0.22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25 ± 4.88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400817837"/>
                  </a:ext>
                </a:extLst>
              </a:tr>
              <a:tr h="16143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P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2313569165"/>
                  </a:ext>
                </a:extLst>
              </a:tr>
              <a:tr h="161434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m 24h vs. Acute 24h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84 ± 0.1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23 ± 2.1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50 ± 0.22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.56 ± 3.51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1531901353"/>
                  </a:ext>
                </a:extLst>
              </a:tr>
              <a:tr h="161434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m 24h + NAC vs. Acute 24h+NA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58 ± 0.1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.99 ± 3.1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69 ± 0.1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50 ± 1.6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726" marR="6726" marT="6726" marB="0" anchor="b"/>
                </a:tc>
                <a:extLst>
                  <a:ext uri="{0D108BD9-81ED-4DB2-BD59-A6C34878D82A}">
                    <a16:rowId xmlns:a16="http://schemas.microsoft.com/office/drawing/2014/main" val="330520458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848040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D2ADC13-63DD-444B-992A-33217AC041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1074355"/>
              </p:ext>
            </p:extLst>
          </p:nvPr>
        </p:nvGraphicFramePr>
        <p:xfrm>
          <a:off x="798005" y="1017599"/>
          <a:ext cx="9751925" cy="4203824"/>
        </p:xfrm>
        <a:graphic>
          <a:graphicData uri="http://schemas.openxmlformats.org/drawingml/2006/table">
            <a:tbl>
              <a:tblPr bandRow="1">
                <a:tableStyleId>{5940675A-B579-460E-94D1-54222C63F5DA}</a:tableStyleId>
              </a:tblPr>
              <a:tblGrid>
                <a:gridCol w="3958632">
                  <a:extLst>
                    <a:ext uri="{9D8B030D-6E8A-4147-A177-3AD203B41FA5}">
                      <a16:colId xmlns:a16="http://schemas.microsoft.com/office/drawing/2014/main" val="2127766096"/>
                    </a:ext>
                  </a:extLst>
                </a:gridCol>
                <a:gridCol w="1998179">
                  <a:extLst>
                    <a:ext uri="{9D8B030D-6E8A-4147-A177-3AD203B41FA5}">
                      <a16:colId xmlns:a16="http://schemas.microsoft.com/office/drawing/2014/main" val="4134126007"/>
                    </a:ext>
                  </a:extLst>
                </a:gridCol>
                <a:gridCol w="2199648">
                  <a:extLst>
                    <a:ext uri="{9D8B030D-6E8A-4147-A177-3AD203B41FA5}">
                      <a16:colId xmlns:a16="http://schemas.microsoft.com/office/drawing/2014/main" val="520291758"/>
                    </a:ext>
                  </a:extLst>
                </a:gridCol>
                <a:gridCol w="1595466">
                  <a:extLst>
                    <a:ext uri="{9D8B030D-6E8A-4147-A177-3AD203B41FA5}">
                      <a16:colId xmlns:a16="http://schemas.microsoft.com/office/drawing/2014/main" val="314622228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GB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 anemia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14)</a:t>
                      </a:r>
                      <a:endParaRPr lang="en-GB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emia</a:t>
                      </a:r>
                      <a:r>
                        <a:rPr lang="en-GB" sz="12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11)</a:t>
                      </a:r>
                      <a:endParaRPr lang="en-GB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</a:t>
                      </a:r>
                      <a:r>
                        <a:rPr lang="de-DE" sz="12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ue</a:t>
                      </a:r>
                      <a:endParaRPr lang="en-GB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1558259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(years), median</a:t>
                      </a:r>
                      <a:r>
                        <a:rPr lang="en-GB" sz="1200" b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IQR)</a:t>
                      </a:r>
                      <a:endParaRPr lang="en-GB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.5 (</a:t>
                      </a:r>
                      <a:r>
                        <a:rPr lang="en-GB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 – 65</a:t>
                      </a:r>
                      <a:r>
                        <a:rPr lang="en-GB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</a:t>
                      </a:r>
                      <a:r>
                        <a:rPr lang="en-GB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n-GB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 – 81</a:t>
                      </a:r>
                      <a:r>
                        <a:rPr lang="en-GB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3</a:t>
                      </a:r>
                      <a:endParaRPr lang="en-GB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1327907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r>
                        <a:rPr lang="en-GB" sz="1200" b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ex, n (%)</a:t>
                      </a:r>
                      <a:endParaRPr lang="en-GB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6 (75)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(57.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9867438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MI (kg/m</a:t>
                      </a:r>
                      <a:r>
                        <a:rPr lang="de-DE" sz="1200" b="1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de-DE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,</a:t>
                      </a:r>
                      <a:r>
                        <a:rPr lang="en-GB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edian</a:t>
                      </a:r>
                      <a:r>
                        <a:rPr lang="en-GB" sz="1200" b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IQR)</a:t>
                      </a:r>
                      <a:endParaRPr lang="en-GB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6 (25.0-26.4)</a:t>
                      </a:r>
                      <a:endParaRPr lang="en-GB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9 (24.6-29)</a:t>
                      </a:r>
                      <a:endParaRPr lang="en-GB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5</a:t>
                      </a:r>
                      <a:endParaRPr lang="en-GB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78771016"/>
                  </a:ext>
                </a:extLst>
              </a:tr>
              <a:tr h="419455">
                <a:tc>
                  <a:txBody>
                    <a:bodyPr/>
                    <a:lstStyle/>
                    <a:p>
                      <a:r>
                        <a:rPr lang="en-GB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ertension, n </a:t>
                      </a:r>
                      <a:r>
                        <a:rPr lang="en-GB" sz="1200" b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GB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9 (64.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(54.5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86658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betes mellitus, n</a:t>
                      </a:r>
                      <a:r>
                        <a:rPr lang="en-GB" sz="1200" b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%)</a:t>
                      </a:r>
                      <a:endParaRPr lang="en-GB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2 (14.2)</a:t>
                      </a:r>
                      <a:endParaRPr lang="en-GB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 (9.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r>
                        <a:rPr lang="en-GB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9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9492625"/>
                  </a:ext>
                </a:extLst>
              </a:tr>
              <a:tr h="370609">
                <a:tc>
                  <a:txBody>
                    <a:bodyPr/>
                    <a:lstStyle/>
                    <a:p>
                      <a:r>
                        <a:rPr lang="de-DE" sz="12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ve</a:t>
                      </a:r>
                      <a:r>
                        <a:rPr lang="de-DE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2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moking</a:t>
                      </a:r>
                      <a:r>
                        <a:rPr lang="de-DE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n </a:t>
                      </a:r>
                      <a:r>
                        <a:rPr lang="en-GB" sz="1200" b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GB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6 (42.8)</a:t>
                      </a:r>
                      <a:endParaRPr lang="en-GB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18.1)</a:t>
                      </a:r>
                      <a:endParaRPr lang="en-GB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577127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R (</a:t>
                      </a:r>
                      <a:r>
                        <a:rPr lang="en-GB" sz="1200" b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l</a:t>
                      </a:r>
                      <a:r>
                        <a:rPr lang="de-DE" sz="1200" b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min/1.73m</a:t>
                      </a:r>
                      <a:r>
                        <a:rPr lang="de-DE" sz="1200" b="1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</a:t>
                      </a:r>
                      <a:r>
                        <a:rPr lang="de-DE" sz="1200" b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GB" sz="1200" b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median (IQR)</a:t>
                      </a:r>
                      <a:endParaRPr lang="en-GB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81.5 (72-9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 (44-8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4</a:t>
                      </a:r>
                      <a:endParaRPr lang="en-GB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781984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moglobin (g/dl), median (IQR)</a:t>
                      </a:r>
                      <a:endParaRPr lang="en-GB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4.2 (13.6-15.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1</a:t>
                      </a:r>
                      <a:r>
                        <a:rPr lang="de-DE" sz="12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10.4-11.5)</a:t>
                      </a:r>
                      <a:endParaRPr lang="de-DE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</a:t>
                      </a:r>
                      <a:endParaRPr lang="en-GB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93833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MI n </a:t>
                      </a:r>
                      <a:r>
                        <a:rPr lang="en-GB" sz="1200" b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GB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 (92.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 (45.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3</a:t>
                      </a:r>
                      <a:endParaRPr lang="en-GB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640571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TEMI n </a:t>
                      </a:r>
                      <a:r>
                        <a:rPr lang="en-GB" sz="1200" b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lang="en-GB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7.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(36.3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3</a:t>
                      </a:r>
                      <a:endParaRPr lang="en-GB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en-GB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48213621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B74D9819-4ED0-4EC8-AE14-41F28A81272A}"/>
              </a:ext>
            </a:extLst>
          </p:cNvPr>
          <p:cNvSpPr txBox="1"/>
          <p:nvPr/>
        </p:nvSpPr>
        <p:spPr>
          <a:xfrm>
            <a:off x="744235" y="498715"/>
            <a:ext cx="98594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b="1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4</a:t>
            </a:r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atient characteristics </a:t>
            </a:r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ACS </a:t>
            </a:r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anemia and without anemia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D7DC8FE-4318-40B5-A6E2-5169A3D966BF}"/>
              </a:ext>
            </a:extLst>
          </p:cNvPr>
          <p:cNvSpPr txBox="1"/>
          <p:nvPr/>
        </p:nvSpPr>
        <p:spPr>
          <a:xfrm>
            <a:off x="507021" y="5363347"/>
            <a:ext cx="1071196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4.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characteristics of ACS patients with and without anemia. </a:t>
            </a:r>
            <a:r>
              <a:rPr lang="en-GB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hi-square test was used to compare between two categorical variables. Depending on the distribution of the data, either the student’s t-test or the Mann–Whitney U test was used to compare variables between the two groups. BMI: body mass index; IQR: interquartile range; GFR: glomerular filtration rate;</a:t>
            </a:r>
            <a:r>
              <a:rPr lang="en-GB" sz="14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n</a:t>
            </a:r>
            <a:r>
              <a:rPr lang="en-GB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number of patients. The patient samples listed in this table were used for the experiments presented in Figure 6D–F.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51547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61</Words>
  <Application>Microsoft Office PowerPoint</Application>
  <PresentationFormat>Widescreen</PresentationFormat>
  <Paragraphs>34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</vt:lpstr>
      <vt:lpstr>PowerPoint Presentation</vt:lpstr>
      <vt:lpstr>PowerPoint Presentation</vt:lpstr>
      <vt:lpstr>PowerPoint Presentation</vt:lpstr>
      <vt:lpstr>PowerPoint Presentation</vt:lpstr>
    </vt:vector>
  </TitlesOfParts>
  <Company>UK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IMS</dc:creator>
  <cp:lastModifiedBy>RAC</cp:lastModifiedBy>
  <cp:revision>55</cp:revision>
  <cp:lastPrinted>2024-09-28T12:24:51Z</cp:lastPrinted>
  <dcterms:created xsi:type="dcterms:W3CDTF">2024-06-18T11:29:34Z</dcterms:created>
  <dcterms:modified xsi:type="dcterms:W3CDTF">2025-09-18T07:08:59Z</dcterms:modified>
</cp:coreProperties>
</file>